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36" r:id="rId2"/>
  </p:sldIdLst>
  <p:sldSz cx="9144000" cy="6858000" type="screen4x3"/>
  <p:notesSz cx="6735763" cy="986631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sz="2400" b="1" kern="1200">
        <a:solidFill>
          <a:schemeClr val="tx1"/>
        </a:solidFill>
        <a:latin typeface="ＭＳ ゴシック" panose="020B0609070205080204" pitchFamily="49" charset="-128"/>
        <a:ea typeface="ＭＳ ゴシック" panose="020B0609070205080204" pitchFamily="49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sz="2400" b="1" kern="1200">
        <a:solidFill>
          <a:schemeClr val="tx1"/>
        </a:solidFill>
        <a:latin typeface="ＭＳ ゴシック" panose="020B0609070205080204" pitchFamily="49" charset="-128"/>
        <a:ea typeface="ＭＳ ゴシック" panose="020B0609070205080204" pitchFamily="49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sz="2400" b="1" kern="1200">
        <a:solidFill>
          <a:schemeClr val="tx1"/>
        </a:solidFill>
        <a:latin typeface="ＭＳ ゴシック" panose="020B0609070205080204" pitchFamily="49" charset="-128"/>
        <a:ea typeface="ＭＳ ゴシック" panose="020B0609070205080204" pitchFamily="49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sz="2400" b="1" kern="1200">
        <a:solidFill>
          <a:schemeClr val="tx1"/>
        </a:solidFill>
        <a:latin typeface="ＭＳ ゴシック" panose="020B0609070205080204" pitchFamily="49" charset="-128"/>
        <a:ea typeface="ＭＳ ゴシック" panose="020B0609070205080204" pitchFamily="49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sz="2400" b="1" kern="1200">
        <a:solidFill>
          <a:schemeClr val="tx1"/>
        </a:solidFill>
        <a:latin typeface="ＭＳ ゴシック" panose="020B0609070205080204" pitchFamily="49" charset="-128"/>
        <a:ea typeface="ＭＳ ゴシック" panose="020B0609070205080204" pitchFamily="49" charset="-128"/>
        <a:cs typeface="+mn-cs"/>
      </a:defRPr>
    </a:lvl5pPr>
    <a:lvl6pPr marL="2286000" algn="l" defTabSz="914400" rtl="0" eaLnBrk="1" latinLnBrk="0" hangingPunct="1">
      <a:defRPr kumimoji="1" sz="2400" b="1" kern="1200">
        <a:solidFill>
          <a:schemeClr val="tx1"/>
        </a:solidFill>
        <a:latin typeface="ＭＳ ゴシック" panose="020B0609070205080204" pitchFamily="49" charset="-128"/>
        <a:ea typeface="ＭＳ ゴシック" panose="020B0609070205080204" pitchFamily="49" charset="-128"/>
        <a:cs typeface="+mn-cs"/>
      </a:defRPr>
    </a:lvl6pPr>
    <a:lvl7pPr marL="2743200" algn="l" defTabSz="914400" rtl="0" eaLnBrk="1" latinLnBrk="0" hangingPunct="1">
      <a:defRPr kumimoji="1" sz="2400" b="1" kern="1200">
        <a:solidFill>
          <a:schemeClr val="tx1"/>
        </a:solidFill>
        <a:latin typeface="ＭＳ ゴシック" panose="020B0609070205080204" pitchFamily="49" charset="-128"/>
        <a:ea typeface="ＭＳ ゴシック" panose="020B0609070205080204" pitchFamily="49" charset="-128"/>
        <a:cs typeface="+mn-cs"/>
      </a:defRPr>
    </a:lvl7pPr>
    <a:lvl8pPr marL="3200400" algn="l" defTabSz="914400" rtl="0" eaLnBrk="1" latinLnBrk="0" hangingPunct="1">
      <a:defRPr kumimoji="1" sz="2400" b="1" kern="1200">
        <a:solidFill>
          <a:schemeClr val="tx1"/>
        </a:solidFill>
        <a:latin typeface="ＭＳ ゴシック" panose="020B0609070205080204" pitchFamily="49" charset="-128"/>
        <a:ea typeface="ＭＳ ゴシック" panose="020B0609070205080204" pitchFamily="49" charset="-128"/>
        <a:cs typeface="+mn-cs"/>
      </a:defRPr>
    </a:lvl8pPr>
    <a:lvl9pPr marL="3657600" algn="l" defTabSz="914400" rtl="0" eaLnBrk="1" latinLnBrk="0" hangingPunct="1">
      <a:defRPr kumimoji="1" sz="2400" b="1" kern="1200">
        <a:solidFill>
          <a:schemeClr val="tx1"/>
        </a:solidFill>
        <a:latin typeface="ＭＳ ゴシック" panose="020B0609070205080204" pitchFamily="49" charset="-128"/>
        <a:ea typeface="ＭＳ ゴシック" panose="020B0609070205080204" pitchFamily="49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08">
          <p15:clr>
            <a:srgbClr val="A4A3A4"/>
          </p15:clr>
        </p15:guide>
        <p15:guide id="2" pos="2122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05" autoAdjust="0"/>
    <p:restoredTop sz="94822" autoAdjust="0"/>
  </p:normalViewPr>
  <p:slideViewPr>
    <p:cSldViewPr showGuides="1">
      <p:cViewPr varScale="1">
        <p:scale>
          <a:sx n="68" d="100"/>
          <a:sy n="68" d="100"/>
        </p:scale>
        <p:origin x="436" y="2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 showGuides="1">
      <p:cViewPr varScale="1">
        <p:scale>
          <a:sx n="57" d="100"/>
          <a:sy n="57" d="100"/>
        </p:scale>
        <p:origin x="-1704" y="-72"/>
      </p:cViewPr>
      <p:guideLst>
        <p:guide orient="horz" pos="3108"/>
        <p:guide pos="2122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>
            <a:extLst>
              <a:ext uri="{FF2B5EF4-FFF2-40B4-BE49-F238E27FC236}">
                <a16:creationId xmlns:a16="http://schemas.microsoft.com/office/drawing/2014/main" id="{140B21E3-786F-4468-93D2-1D99025632C3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9413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1" hangingPunct="1">
              <a:defRPr sz="1200" b="0">
                <a:latin typeface="Times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195" name="Rectangle 3">
            <a:extLst>
              <a:ext uri="{FF2B5EF4-FFF2-40B4-BE49-F238E27FC236}">
                <a16:creationId xmlns:a16="http://schemas.microsoft.com/office/drawing/2014/main" id="{0AA829F5-0B93-D637-D71A-54A9AFBC5FD6}"/>
              </a:ext>
            </a:extLst>
          </p:cNvPr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16350" y="0"/>
            <a:ext cx="2919413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 b="0">
                <a:latin typeface="Times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196" name="Rectangle 4">
            <a:extLst>
              <a:ext uri="{FF2B5EF4-FFF2-40B4-BE49-F238E27FC236}">
                <a16:creationId xmlns:a16="http://schemas.microsoft.com/office/drawing/2014/main" id="{8EFF72BB-B6F5-C823-D4A1-FFA3ADC5F796}"/>
              </a:ext>
            </a:extLst>
          </p:cNvPr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2600"/>
            <a:ext cx="2919413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 eaLnBrk="1" hangingPunct="1">
              <a:defRPr sz="1200" b="0">
                <a:latin typeface="Times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197" name="Rectangle 5">
            <a:extLst>
              <a:ext uri="{FF2B5EF4-FFF2-40B4-BE49-F238E27FC236}">
                <a16:creationId xmlns:a16="http://schemas.microsoft.com/office/drawing/2014/main" id="{AB7DD31C-D57D-230D-E92F-263E3CB7C69F}"/>
              </a:ext>
            </a:extLst>
          </p:cNvPr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16350" y="9372600"/>
            <a:ext cx="2919413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b="0">
                <a:latin typeface="Times" pitchFamily="2" charset="0"/>
              </a:defRPr>
            </a:lvl1pPr>
          </a:lstStyle>
          <a:p>
            <a:pPr>
              <a:defRPr/>
            </a:pPr>
            <a:fld id="{A19A3ADC-9F0E-1543-A7DB-957F82A5E82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0" name="Rectangle 2">
            <a:extLst>
              <a:ext uri="{FF2B5EF4-FFF2-40B4-BE49-F238E27FC236}">
                <a16:creationId xmlns:a16="http://schemas.microsoft.com/office/drawing/2014/main" id="{5689A742-84FA-A987-5526-CE74A49811B8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9413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7891" name="Rectangle 3">
            <a:extLst>
              <a:ext uri="{FF2B5EF4-FFF2-40B4-BE49-F238E27FC236}">
                <a16:creationId xmlns:a16="http://schemas.microsoft.com/office/drawing/2014/main" id="{A0640A29-5E24-34F3-6FA2-D80DDC2559FA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3816350" y="0"/>
            <a:ext cx="2919413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052" name="Rectangle 4">
            <a:extLst>
              <a:ext uri="{FF2B5EF4-FFF2-40B4-BE49-F238E27FC236}">
                <a16:creationId xmlns:a16="http://schemas.microsoft.com/office/drawing/2014/main" id="{0EE41F76-E0E8-9BAC-AF3A-A1E3C9EE0940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01700" y="739775"/>
            <a:ext cx="4932363" cy="37004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7893" name="Rectangle 5">
            <a:extLst>
              <a:ext uri="{FF2B5EF4-FFF2-40B4-BE49-F238E27FC236}">
                <a16:creationId xmlns:a16="http://schemas.microsoft.com/office/drawing/2014/main" id="{45D47582-A827-AC5C-DB1F-271FE296B745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98525" y="4686300"/>
            <a:ext cx="4938713" cy="4440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37894" name="Rectangle 6">
            <a:extLst>
              <a:ext uri="{FF2B5EF4-FFF2-40B4-BE49-F238E27FC236}">
                <a16:creationId xmlns:a16="http://schemas.microsoft.com/office/drawing/2014/main" id="{81E6DBAA-A8CE-7726-759D-29CBAB5FDEF8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2600"/>
            <a:ext cx="2919413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7895" name="Rectangle 7">
            <a:extLst>
              <a:ext uri="{FF2B5EF4-FFF2-40B4-BE49-F238E27FC236}">
                <a16:creationId xmlns:a16="http://schemas.microsoft.com/office/drawing/2014/main" id="{78226C1F-6426-F9A0-614E-C0F41B9FB88B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16350" y="9372600"/>
            <a:ext cx="2919413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A8EADE66-9271-0243-962E-F04F8123F16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A8EADE66-9271-0243-962E-F04F8123F164}" type="slidenum">
              <a:rPr lang="en-US" altLang="ja-JP" smtClean="0"/>
              <a:pPr>
                <a:defRPr/>
              </a:pPr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606105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DA1A40AF-5E56-6F4B-D934-E45528EB6FBF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C5C8DC4E-4CF1-F053-1357-BD9A2792B604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CF2340A2-A289-0D37-33B0-D7BACFF7B8E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44E3C5-2BD3-5045-A9D8-E718F0668C4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31580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2B1BD671-1BC7-073C-816E-15083EAF1D84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E2E477F1-B259-1BF3-C519-E074762E5964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41A156FB-A41A-9ABC-D61F-7F12EED2610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220825-3DA7-984D-A9AD-0A40F2827A5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38563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D91613D0-DDCD-31F5-2281-2A82EAAB0D1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A8FCFD80-FD6F-100A-01D4-D4E7974ADBD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CE220C1-D09D-B841-A0A6-3EE54D887179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51D37B1-F201-934A-8B8D-7ABDDB4653E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945966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CECD2DF4-3DC9-0FB0-9529-7332800A008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6DD1993D-C746-CDFB-070B-C1798F86954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C64DCA87-FA2D-72B8-BB3B-6BBAE9BA941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16C9EA-A046-644D-9C72-9919646CCBD5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133731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2AB7E29E-102B-7E76-0642-FD45E5B8DC3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68A56C98-28F9-576E-38E6-D723F11FDF00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96DBC5A6-44A6-AD3B-E67D-63F0810CA9C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892C3B0-8D48-2041-9345-F1E12C61CDF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227256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E7357BC-6264-20D0-6A75-2A9067C41562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EA17EBA-3C1A-3A3D-DC58-2F864AD08053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4B46C10-6925-0CAB-E98C-31A1629BC7D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C62B956-2764-2C4D-9B02-C9B8C035ED3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67438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4078D2B2-39E9-7DF7-7659-39BD5DF5A6C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E3306790-3714-ED8A-FCD9-AFCDB22F4EE3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6E22BA39-2DDC-452B-880D-E4CC631C094E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F6F6DA0-2DE2-C145-9B20-F4205E4AF73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17902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289A7CC3-551C-7A6E-D3AC-6B79FF9B08CE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6A40AA97-E619-17DF-2B95-FADB8B97631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A363C95F-D1DD-4799-0C7F-92BAC9063CE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747B744-10DF-0147-B5B8-E13627A787F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136333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63ADA3C4-5F2C-DA49-5839-E150A2F1C78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CB4642BC-5593-064A-F193-684E309BB49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3BECFCD0-7773-8D74-F713-F819B9F0A079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26A73F8-E5C8-2F4C-B055-7EEF4EB20AB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106281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1B82229-8DBF-4578-7192-4D381DB4BCFE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C96FFDE-C6DE-739B-89C6-EB43C9A1638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48204FD-0F03-8A76-2D62-9CD125B7A0F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552643-3803-E841-985E-CA47CEDF93A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036658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3E2431C-F78F-904C-313D-43A3E2DCEDE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FEB3519-4343-FB64-4DEC-1D6B032B7B8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64E5F66-12DA-7632-F88D-EA334E2D8F7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1345AA-78F5-8844-B221-7289434BB71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777929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232659A5-E14C-B401-D76D-B1C959016011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575FB27C-5203-3C71-AA5A-5B5C114CE347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22A04261-5FC8-79F8-3D62-F00DED9D4D6E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1" hangingPunct="1">
              <a:defRPr sz="1400" b="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BBB44A39-BA79-13F5-9277-6E3EDA4FA2D5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 b="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07A63F72-82E1-4DE2-9D62-62FCCC16C790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 b="0">
                <a:latin typeface="Times" pitchFamily="2" charset="0"/>
                <a:ea typeface="Osaka" panose="020B0600000000000000" pitchFamily="34" charset="-128"/>
              </a:defRPr>
            </a:lvl1pPr>
          </a:lstStyle>
          <a:p>
            <a:pPr>
              <a:defRPr/>
            </a:pPr>
            <a:fld id="{6900A09A-9CFA-B544-BECD-C903BF69F9A5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4">
            <a:extLst>
              <a:ext uri="{FF2B5EF4-FFF2-40B4-BE49-F238E27FC236}">
                <a16:creationId xmlns:a16="http://schemas.microsoft.com/office/drawing/2014/main" id="{EFF6E60A-952D-BE90-8E9D-08D108FB02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3775" y="2924944"/>
            <a:ext cx="4648200" cy="285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22">
            <a:extLst>
              <a:ext uri="{FF2B5EF4-FFF2-40B4-BE49-F238E27FC236}">
                <a16:creationId xmlns:a16="http://schemas.microsoft.com/office/drawing/2014/main" id="{2FF76C9F-E300-2D73-9CE2-EAFF155785A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51163" y="239713"/>
            <a:ext cx="3276600" cy="2468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1" name="Text Box 90">
            <a:extLst>
              <a:ext uri="{FF2B5EF4-FFF2-40B4-BE49-F238E27FC236}">
                <a16:creationId xmlns:a16="http://schemas.microsoft.com/office/drawing/2014/main" id="{19E4263A-970B-E996-2527-0CAD8445BE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5063" y="5166494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0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02" name="Text Box 90">
            <a:extLst>
              <a:ext uri="{FF2B5EF4-FFF2-40B4-BE49-F238E27FC236}">
                <a16:creationId xmlns:a16="http://schemas.microsoft.com/office/drawing/2014/main" id="{31BEA09A-5D31-D020-7437-72B108B790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4015" y="2687638"/>
            <a:ext cx="3818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(b)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03" name="Text Box 90">
            <a:extLst>
              <a:ext uri="{FF2B5EF4-FFF2-40B4-BE49-F238E27FC236}">
                <a16:creationId xmlns:a16="http://schemas.microsoft.com/office/drawing/2014/main" id="{53948761-CB36-69D0-8BE9-467EBF60F0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3632" y="-26988"/>
            <a:ext cx="3722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(a)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04" name="Text Box 90">
            <a:extLst>
              <a:ext uri="{FF2B5EF4-FFF2-40B4-BE49-F238E27FC236}">
                <a16:creationId xmlns:a16="http://schemas.microsoft.com/office/drawing/2014/main" id="{EAEB58C4-4AD6-CE86-76B4-8AE941BE4F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9622" y="5382394"/>
            <a:ext cx="43954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400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05" name="Text Box 90">
            <a:extLst>
              <a:ext uri="{FF2B5EF4-FFF2-40B4-BE49-F238E27FC236}">
                <a16:creationId xmlns:a16="http://schemas.microsoft.com/office/drawing/2014/main" id="{B8C5E02A-B65A-2A93-6C98-DE28219070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8257" y="2988444"/>
            <a:ext cx="4395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200" b="0" dirty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100</a:t>
            </a:r>
            <a:endParaRPr lang="ja-JP" altLang="en-US" sz="1200" b="0" dirty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06" name="Text Box 90">
            <a:extLst>
              <a:ext uri="{FF2B5EF4-FFF2-40B4-BE49-F238E27FC236}">
                <a16:creationId xmlns:a16="http://schemas.microsoft.com/office/drawing/2014/main" id="{7EBE3C7D-84D2-DCD3-541C-E51C834579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6272" y="5382394"/>
            <a:ext cx="43954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500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07" name="Text Box 90">
            <a:extLst>
              <a:ext uri="{FF2B5EF4-FFF2-40B4-BE49-F238E27FC236}">
                <a16:creationId xmlns:a16="http://schemas.microsoft.com/office/drawing/2014/main" id="{28E5F1BD-DB82-CFD0-2D47-84E58D7007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9747" y="5382394"/>
            <a:ext cx="43954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600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08" name="Text Box 90">
            <a:extLst>
              <a:ext uri="{FF2B5EF4-FFF2-40B4-BE49-F238E27FC236}">
                <a16:creationId xmlns:a16="http://schemas.microsoft.com/office/drawing/2014/main" id="{63E33157-A83D-7D82-7817-4E339FC960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7191" y="5382394"/>
            <a:ext cx="43954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700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09" name="Text Box 90">
            <a:extLst>
              <a:ext uri="{FF2B5EF4-FFF2-40B4-BE49-F238E27FC236}">
                <a16:creationId xmlns:a16="http://schemas.microsoft.com/office/drawing/2014/main" id="{D86A9FC8-CEB2-15B0-D629-47F4D2A66C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4088" y="5659333"/>
            <a:ext cx="134754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Wavelength (nm)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10" name="Text Box 90">
            <a:extLst>
              <a:ext uri="{FF2B5EF4-FFF2-40B4-BE49-F238E27FC236}">
                <a16:creationId xmlns:a16="http://schemas.microsoft.com/office/drawing/2014/main" id="{0476EBF5-E10E-E67C-F324-9DE8EA6393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5102" y="3442469"/>
            <a:ext cx="62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Green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11" name="Text Box 90">
            <a:extLst>
              <a:ext uri="{FF2B5EF4-FFF2-40B4-BE49-F238E27FC236}">
                <a16:creationId xmlns:a16="http://schemas.microsoft.com/office/drawing/2014/main" id="{64763E93-E437-79DB-F8FC-CF4D7E39E1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21995" y="3777432"/>
            <a:ext cx="4748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Red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12" name="Text Box 90">
            <a:extLst>
              <a:ext uri="{FF2B5EF4-FFF2-40B4-BE49-F238E27FC236}">
                <a16:creationId xmlns:a16="http://schemas.microsoft.com/office/drawing/2014/main" id="{5D92EA64-EBF6-A292-B76F-AC775E7F7B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0223" y="3825057"/>
            <a:ext cx="4908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Blue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4113" name="Text Box 90">
            <a:extLst>
              <a:ext uri="{FF2B5EF4-FFF2-40B4-BE49-F238E27FC236}">
                <a16:creationId xmlns:a16="http://schemas.microsoft.com/office/drawing/2014/main" id="{667D6BE9-33D9-99AF-4F6E-4968D364AB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8221" y="3272607"/>
            <a:ext cx="62100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200" b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Yellow</a:t>
            </a:r>
            <a:endParaRPr lang="ja-JP" altLang="en-US" sz="1200" b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cxnSp>
        <p:nvCxnSpPr>
          <p:cNvPr id="4114" name="直線コネクタ 41">
            <a:extLst>
              <a:ext uri="{FF2B5EF4-FFF2-40B4-BE49-F238E27FC236}">
                <a16:creationId xmlns:a16="http://schemas.microsoft.com/office/drawing/2014/main" id="{E269DC1F-B439-CB87-37D6-3337C3AFCAE6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3887788" y="3466282"/>
            <a:ext cx="155575" cy="84137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115" name="直線コネクタ 45">
            <a:extLst>
              <a:ext uri="{FF2B5EF4-FFF2-40B4-BE49-F238E27FC236}">
                <a16:creationId xmlns:a16="http://schemas.microsoft.com/office/drawing/2014/main" id="{2F9F2AEC-A891-13C9-6B0C-8A2DF60F3025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4246563" y="3705994"/>
            <a:ext cx="92075" cy="134938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116" name="直線コネクタ 47">
            <a:extLst>
              <a:ext uri="{FF2B5EF4-FFF2-40B4-BE49-F238E27FC236}">
                <a16:creationId xmlns:a16="http://schemas.microsoft.com/office/drawing/2014/main" id="{E669D631-8EBD-50E6-EBA3-DB90EE37F2BF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4981575" y="3863157"/>
            <a:ext cx="155575" cy="84137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117" name="直線コネクタ 48">
            <a:extLst>
              <a:ext uri="{FF2B5EF4-FFF2-40B4-BE49-F238E27FC236}">
                <a16:creationId xmlns:a16="http://schemas.microsoft.com/office/drawing/2014/main" id="{E81F6737-1592-4AA6-AF55-EB1795C463D9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3286125" y="4088582"/>
            <a:ext cx="90488" cy="136525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118" name="Text Box 90">
            <a:extLst>
              <a:ext uri="{FF2B5EF4-FFF2-40B4-BE49-F238E27FC236}">
                <a16:creationId xmlns:a16="http://schemas.microsoft.com/office/drawing/2014/main" id="{0B9A5AAE-3DDD-4E15-E6E3-040E5A3BBCCC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1563097" y="4127088"/>
            <a:ext cx="127631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panose="020B0600000000000000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0" dirty="0">
                <a:latin typeface="Helvetica" panose="020B0604020202020204" pitchFamily="34" charset="0"/>
                <a:ea typeface="平成角ゴシック" charset="-128"/>
                <a:cs typeface="Helvetica" panose="020B0604020202020204" pitchFamily="34" charset="0"/>
              </a:rPr>
              <a:t>Reflectance (%)</a:t>
            </a:r>
            <a:endParaRPr lang="ja-JP" altLang="en-US" sz="1200" b="0" dirty="0">
              <a:latin typeface="Helvetica" panose="020B0604020202020204" pitchFamily="34" charset="0"/>
              <a:ea typeface="平成角ゴシック" charset="-128"/>
              <a:cs typeface="Helvetica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A1FF658-43D4-FAEC-131E-2DE8ADC9D527}"/>
              </a:ext>
            </a:extLst>
          </p:cNvPr>
          <p:cNvSpPr txBox="1"/>
          <p:nvPr/>
        </p:nvSpPr>
        <p:spPr>
          <a:xfrm>
            <a:off x="131378" y="6037208"/>
            <a:ext cx="8712968" cy="8156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" algn="just"/>
            <a:r>
              <a:rPr lang="en-US" altLang="ja-JP" sz="1200" b="0" kern="100">
                <a:effectLst/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Supplementary fig. 1. (a) Paper flower models and (b) reflection spectra of different colour papers used to make flower models.</a:t>
            </a:r>
            <a:endParaRPr lang="en-US" altLang="ja-JP" sz="500" b="0" kern="100">
              <a:latin typeface="Helvetica" panose="020B0604020202020204" pitchFamily="34" charset="0"/>
              <a:ea typeface="ＭＳ 明朝" panose="02020609040205080304" pitchFamily="17" charset="-128"/>
              <a:cs typeface="Helvetica" panose="020B0604020202020204" pitchFamily="34" charset="0"/>
            </a:endParaRPr>
          </a:p>
          <a:p>
            <a:pPr marL="1270" algn="just"/>
            <a:endParaRPr lang="en-US" altLang="ja-JP" sz="500" b="0" kern="10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270" algn="just"/>
            <a:r>
              <a:rPr lang="en-US" altLang="ja-JP" sz="1000" b="0" kern="10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itle: Reinforced colour preference of parasitoid wasps in the presence of </a:t>
            </a:r>
            <a:r>
              <a:rPr lang="en-US" altLang="ja-JP" sz="1000" b="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loral scent: a case study of a cross-modal effect	</a:t>
            </a:r>
            <a:r>
              <a:rPr lang="en-US" altLang="ja-JP" sz="1000" b="0" kern="1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Journal: Animal Cognition</a:t>
            </a:r>
            <a:endParaRPr lang="en-US" altLang="ja-JP" sz="1000" b="0" kern="100">
              <a:solidFill>
                <a:srgbClr val="000000"/>
              </a:solidFill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270" algn="just"/>
            <a:r>
              <a:rPr lang="en-US" altLang="ja-JP" sz="1000" b="0" kern="1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: Kugimiya S</a:t>
            </a:r>
            <a:r>
              <a:rPr lang="en-US" altLang="ja-JP" sz="1000" b="0" kern="100" baseline="300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†</a:t>
            </a:r>
            <a:r>
              <a:rPr lang="en-US" altLang="ja-JP" sz="1000" b="0" kern="1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moda T, Takabayashi J</a:t>
            </a:r>
          </a:p>
          <a:p>
            <a:pPr marL="1270" algn="just"/>
            <a:r>
              <a:rPr lang="en-US" altLang="ja-JP" sz="1000" b="0" kern="1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ffilation: </a:t>
            </a:r>
            <a:r>
              <a:rPr lang="en-US" altLang="ja-JP" sz="1000" b="0" kern="100" baseline="300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†</a:t>
            </a:r>
            <a:r>
              <a:rPr lang="en-US" altLang="ja-JP" sz="1000" b="0" kern="1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for Plant Protection, National Agriculture and Food Research Organization (NARO)	E-mail: kugimiya@affrc.go.jp</a:t>
            </a:r>
            <a:endParaRPr lang="ja-JP" altLang="ja-JP" sz="1200" b="0" kern="100">
              <a:effectLst/>
              <a:latin typeface="Helvetica" panose="020B0604020202020204" pitchFamily="34" charset="0"/>
              <a:ea typeface="ＭＳ 明朝" panose="02020609040205080304" pitchFamily="17" charset="-128"/>
              <a:cs typeface="Helvetica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Times"/>
        <a:ea typeface="Osaka"/>
        <a:cs typeface=""/>
      </a:majorFont>
      <a:minorFont>
        <a:latin typeface="Times"/>
        <a:ea typeface="Osaka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00B050"/>
        </a:solidFill>
        <a:ln w="19050" cap="flat" cmpd="sng" algn="ctr">
          <a:solidFill>
            <a:schemeClr val="accent4"/>
          </a:solidFill>
          <a:prstDash val="solid"/>
          <a:round/>
          <a:headEnd type="none" w="med" len="med"/>
          <a:tailEnd type="none" w="med" len="med"/>
        </a:ln>
        <a:effectLst/>
      </a:spPr>
      <a:bodyPr/>
      <a:lstStyle>
        <a:defPPr>
          <a:defRPr sz="1600">
            <a:latin typeface="Helvetica" pitchFamily="34" charset="0"/>
            <a:cs typeface="Helvetica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ＭＳ ゴシック" pitchFamily="49" charset="-128"/>
            <a:ea typeface="ＭＳ ゴシック" pitchFamily="49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48</TotalTime>
  <Words>114</Words>
  <Application>Microsoft Office PowerPoint</Application>
  <PresentationFormat>画面に合わせる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ゴシック</vt:lpstr>
      <vt:lpstr>Helvetica</vt:lpstr>
      <vt:lpstr>Times</vt:lpstr>
      <vt:lpstr>Times New Roman</vt:lpstr>
      <vt:lpstr>新しいプレゼンテーション</vt:lpstr>
      <vt:lpstr>PowerPoint プレゼンテーション</vt:lpstr>
    </vt:vector>
  </TitlesOfParts>
  <Company>京都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釘宮聡一</dc:creator>
  <cp:lastModifiedBy>釘宮 聡一</cp:lastModifiedBy>
  <cp:revision>364</cp:revision>
  <cp:lastPrinted>2007-03-23T12:27:41Z</cp:lastPrinted>
  <dcterms:created xsi:type="dcterms:W3CDTF">2007-03-23T10:47:51Z</dcterms:created>
  <dcterms:modified xsi:type="dcterms:W3CDTF">2024-02-29T17:37:03Z</dcterms:modified>
</cp:coreProperties>
</file>